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2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8" autoAdjust="0"/>
    <p:restoredTop sz="94660"/>
  </p:normalViewPr>
  <p:slideViewPr>
    <p:cSldViewPr snapToGrid="0">
      <p:cViewPr varScale="1">
        <p:scale>
          <a:sx n="98" d="100"/>
          <a:sy n="98" d="100"/>
        </p:scale>
        <p:origin x="52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&#24037;&#20316;&#31807;4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90639F"/>
            </a:solidFill>
            <a:ln>
              <a:noFill/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rgbClr val="54823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8F8C-42BE-ADFD-E0D0BC8FD08E}"/>
              </c:ext>
            </c:extLst>
          </c:dPt>
          <c:dPt>
            <c:idx val="3"/>
            <c:invertIfNegative val="0"/>
            <c:bubble3D val="0"/>
            <c:spPr>
              <a:solidFill>
                <a:srgbClr val="54823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8F8C-42BE-ADFD-E0D0BC8FD08E}"/>
              </c:ext>
            </c:extLst>
          </c:dPt>
          <c:dPt>
            <c:idx val="4"/>
            <c:invertIfNegative val="0"/>
            <c:bubble3D val="0"/>
            <c:spPr>
              <a:solidFill>
                <a:srgbClr val="54823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4-8F8C-42BE-ADFD-E0D0BC8FD08E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I$7:$I$11</c:f>
                <c:numCache>
                  <c:formatCode>General</c:formatCode>
                  <c:ptCount val="5"/>
                  <c:pt idx="0">
                    <c:v>2.7655040997228437</c:v>
                  </c:pt>
                  <c:pt idx="1">
                    <c:v>1.8014922586582902</c:v>
                  </c:pt>
                  <c:pt idx="2">
                    <c:v>1.3487417792720315</c:v>
                  </c:pt>
                  <c:pt idx="3">
                    <c:v>0.691590385964445</c:v>
                  </c:pt>
                  <c:pt idx="4">
                    <c:v>0.303893815604366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7:$G$11</c:f>
              <c:strCache>
                <c:ptCount val="5"/>
                <c:pt idx="0">
                  <c:v>PYTC</c:v>
                </c:pt>
                <c:pt idx="1">
                  <c:v>SDZ</c:v>
                </c:pt>
                <c:pt idx="2">
                  <c:v>M9</c:v>
                </c:pt>
                <c:pt idx="3">
                  <c:v>GD</c:v>
                </c:pt>
                <c:pt idx="4">
                  <c:v>HF</c:v>
                </c:pt>
              </c:strCache>
            </c:strRef>
          </c:cat>
          <c:val>
            <c:numRef>
              <c:f>Sheet1!$H$7:$H$11</c:f>
              <c:numCache>
                <c:formatCode>General</c:formatCode>
                <c:ptCount val="5"/>
                <c:pt idx="0">
                  <c:v>7.9678190875030426</c:v>
                </c:pt>
                <c:pt idx="1">
                  <c:v>6.2203841563888735</c:v>
                </c:pt>
                <c:pt idx="2">
                  <c:v>5.8213929201831762</c:v>
                </c:pt>
                <c:pt idx="3">
                  <c:v>1.2802918420712954</c:v>
                </c:pt>
                <c:pt idx="4">
                  <c:v>0.95655767980960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F8C-42BE-ADFD-E0D0BC8FD0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57464808"/>
        <c:axId val="957468088"/>
      </c:barChart>
      <c:catAx>
        <c:axId val="9574648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957468088"/>
        <c:crosses val="autoZero"/>
        <c:auto val="1"/>
        <c:lblAlgn val="ctr"/>
        <c:lblOffset val="100"/>
        <c:noMultiLvlLbl val="0"/>
      </c:catAx>
      <c:valAx>
        <c:axId val="9574680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9574648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90639F"/>
            </a:solidFill>
            <a:ln>
              <a:noFill/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rgbClr val="54823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7BD6-4145-89CD-2C803C94EE80}"/>
              </c:ext>
            </c:extLst>
          </c:dPt>
          <c:dPt>
            <c:idx val="3"/>
            <c:invertIfNegative val="0"/>
            <c:bubble3D val="0"/>
            <c:spPr>
              <a:solidFill>
                <a:srgbClr val="54823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BD6-4145-89CD-2C803C94EE80}"/>
              </c:ext>
            </c:extLst>
          </c:dPt>
          <c:dPt>
            <c:idx val="4"/>
            <c:invertIfNegative val="0"/>
            <c:bubble3D val="0"/>
            <c:spPr>
              <a:solidFill>
                <a:srgbClr val="54823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4-7BD6-4145-89CD-2C803C94EE80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I$24:$I$28</c:f>
                <c:numCache>
                  <c:formatCode>General</c:formatCode>
                  <c:ptCount val="5"/>
                  <c:pt idx="0">
                    <c:v>2.149402978975985</c:v>
                  </c:pt>
                  <c:pt idx="1">
                    <c:v>4.4364042382839974</c:v>
                  </c:pt>
                  <c:pt idx="2">
                    <c:v>3.2412459641382498</c:v>
                  </c:pt>
                  <c:pt idx="3">
                    <c:v>0.71062473250579516</c:v>
                  </c:pt>
                  <c:pt idx="4">
                    <c:v>1.651655533111448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24:$G$28</c:f>
              <c:strCache>
                <c:ptCount val="5"/>
                <c:pt idx="0">
                  <c:v>PYTC</c:v>
                </c:pt>
                <c:pt idx="1">
                  <c:v>SDZ</c:v>
                </c:pt>
                <c:pt idx="2">
                  <c:v>M9</c:v>
                </c:pt>
                <c:pt idx="3">
                  <c:v>GD</c:v>
                </c:pt>
                <c:pt idx="4">
                  <c:v>HF</c:v>
                </c:pt>
              </c:strCache>
            </c:strRef>
          </c:cat>
          <c:val>
            <c:numRef>
              <c:f>Sheet1!$H$24:$H$28</c:f>
              <c:numCache>
                <c:formatCode>General</c:formatCode>
                <c:ptCount val="5"/>
                <c:pt idx="0">
                  <c:v>20.218010712209999</c:v>
                </c:pt>
                <c:pt idx="1">
                  <c:v>8.6857663768632154</c:v>
                </c:pt>
                <c:pt idx="2">
                  <c:v>16.072369945171669</c:v>
                </c:pt>
                <c:pt idx="3">
                  <c:v>9.7736741315261781</c:v>
                </c:pt>
                <c:pt idx="4">
                  <c:v>7.39722706718944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BD6-4145-89CD-2C803C94EE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52291416"/>
        <c:axId val="952291744"/>
      </c:barChart>
      <c:catAx>
        <c:axId val="9522914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952291744"/>
        <c:crosses val="autoZero"/>
        <c:auto val="1"/>
        <c:lblAlgn val="ctr"/>
        <c:lblOffset val="100"/>
        <c:noMultiLvlLbl val="0"/>
      </c:catAx>
      <c:valAx>
        <c:axId val="9522917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9522914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35B1ED-F86F-4A3D-91B0-93F525F5E2CF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29CFD8-7C1C-4BC9-A9F7-2D549B3ACB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13990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81FCCB-F7A0-47AD-AC20-7C96967510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32770C7-1181-4EBE-AB4F-34A034A60E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49BC00-2C8E-4F9E-8DFC-AD3EFA0979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265B3CB-4DFD-4380-9E33-2D19558021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AB632F5-4004-43BE-A894-48AE73934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49078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9100160-3FDC-44D0-9F62-277CA77C46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DD6F321-DC31-49E0-9A4A-9A631B70C0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83C318-0B67-410A-8C04-26BF21A40E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5BFE5AC-9838-4537-8264-C3CCD4619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25C987-EFEC-46DE-BC11-02CA11634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9336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7C7DCFA-689C-40BD-9587-38DD677E66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0EF6F39-C995-4EF4-AEB1-21FD2E6E8C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0547461-557A-4E09-856C-D537B58D8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0B3021-015A-4A32-9262-E7D2F6440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A3F7901-7663-40B5-A438-AA35C1CB7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7192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FABF3C-2C26-479B-B49D-1563166566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214D1EE-F4EB-45AF-B160-F4E14B9AF5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C2F6C5-6B95-4C43-BD28-3948CB912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072172-9FE6-4C79-BA7E-D449435AF9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F1655CD-FB00-4867-8CC9-38EE57D6A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2436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D904A8-7140-4E15-ABC8-BCACA51AEE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9FE273F-F3BC-4EDA-95A7-287DEAD5A0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34E2D2-2981-4C7A-BBD6-21BAD9FFD1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F92DAE7-75F6-46BC-9353-6AD3807A9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4969101-EBD7-419D-9D1A-0761C02F91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3404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E40A1C-33C3-420A-BE99-561D7CB368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3428511-47B8-4435-BDBD-19796BCFC6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BB3B03E-269F-41C4-B194-26BC20D52A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AFAE765-492A-4702-9F98-B5A0234652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6668DD-9BE5-4181-8236-17007EF08E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F212379-62ED-4F44-B90D-4A98EBE04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2815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B82C16-2549-445F-BD14-00AC56AE5D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A59E935-FF0E-45DC-A42F-A0C23CE059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445E1EA-7914-47D5-AEC1-EDABAE649E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8731DD7-68F7-4EA0-9D34-8247DE5E87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B66F667-0631-4AF0-AA34-78FBE3A81E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E6FFC3E-8156-49E8-BC5F-484077B5E5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8AD6E16-5809-4B02-879A-F014EE1E7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E640E36-B09A-4618-A27B-FF48F82BB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4892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033ABD-8856-47F0-AD8D-81B476E95F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B638DD1-D36C-43EC-87E7-212A2F560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2AC69A6-522A-4D94-9C26-0FA9826639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464667C-7B27-44B4-A899-E9754EABB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5015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2F695B8-0299-4A81-A058-11D1C123E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FF9A398-FA1B-42B3-ABBE-CF2A33DA1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F461A4F-9387-473F-80EC-BB947A23F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3797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FA41EB-ADF1-4171-BA2E-F899D7E1D4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A198B67-43A3-4908-9D87-7B8ED5B3E3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65D3868-63DA-445C-959E-6A81AE1862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7628954-8310-429C-B879-0C39566619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5A5AB87-4358-4C34-A45D-EF19D0A0A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CAEFFEE-FFCE-4767-BC57-900D0AEF22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611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1C9578-790E-4EFC-AD7D-5D36B63495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4CBD583-BC12-4947-B31C-1BE07F03A4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FCEEDC9-0E30-4C91-BAC4-3F5E0985E1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0DD3960-C2F5-4B95-B4A7-AE98605461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86B8756-5B6D-4A90-A48F-2FCFD92B9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68163B7-88DA-4D9C-B1AB-1B7E8AB22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5464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01A57E7-A18D-43AF-87BE-53F6DC0D9B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202DFA5-BB78-4CA9-9DFC-E9447FA528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CEB0252-DAC6-4D3D-99B9-395345D5B1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DE0D05-08B2-46BF-91F3-5A6DA98064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19C1876-B017-4C34-BD68-5098EEA457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1411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7" Type="http://schemas.openxmlformats.org/officeDocument/2006/relationships/chart" Target="../charts/chart2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.xml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组合 47">
            <a:extLst>
              <a:ext uri="{FF2B5EF4-FFF2-40B4-BE49-F238E27FC236}">
                <a16:creationId xmlns:a16="http://schemas.microsoft.com/office/drawing/2014/main" id="{28AAD9EF-B2B0-43B5-8379-2CD414C1B2D9}"/>
              </a:ext>
            </a:extLst>
          </p:cNvPr>
          <p:cNvGrpSpPr/>
          <p:nvPr/>
        </p:nvGrpSpPr>
        <p:grpSpPr>
          <a:xfrm>
            <a:off x="2232652" y="844675"/>
            <a:ext cx="7965448" cy="3959493"/>
            <a:chOff x="1445252" y="838325"/>
            <a:chExt cx="7965448" cy="3959493"/>
          </a:xfrm>
        </p:grpSpPr>
        <p:grpSp>
          <p:nvGrpSpPr>
            <p:cNvPr id="43" name="组合 42">
              <a:extLst>
                <a:ext uri="{FF2B5EF4-FFF2-40B4-BE49-F238E27FC236}">
                  <a16:creationId xmlns:a16="http://schemas.microsoft.com/office/drawing/2014/main" id="{273B12E4-A13A-4CE5-BB5D-710DD6589F10}"/>
                </a:ext>
              </a:extLst>
            </p:cNvPr>
            <p:cNvGrpSpPr/>
            <p:nvPr/>
          </p:nvGrpSpPr>
          <p:grpSpPr>
            <a:xfrm>
              <a:off x="1653577" y="900122"/>
              <a:ext cx="5969001" cy="1825560"/>
              <a:chOff x="1653577" y="900122"/>
              <a:chExt cx="5969001" cy="1825560"/>
            </a:xfrm>
          </p:grpSpPr>
          <p:grpSp>
            <p:nvGrpSpPr>
              <p:cNvPr id="45" name="组合 44">
                <a:extLst>
                  <a:ext uri="{FF2B5EF4-FFF2-40B4-BE49-F238E27FC236}">
                    <a16:creationId xmlns:a16="http://schemas.microsoft.com/office/drawing/2014/main" id="{586D37A9-0EBC-406D-816A-CDCD9D47BE01}"/>
                  </a:ext>
                </a:extLst>
              </p:cNvPr>
              <p:cNvGrpSpPr/>
              <p:nvPr/>
            </p:nvGrpSpPr>
            <p:grpSpPr>
              <a:xfrm>
                <a:off x="1653577" y="900122"/>
                <a:ext cx="1562508" cy="1730932"/>
                <a:chOff x="2679237" y="564035"/>
                <a:chExt cx="2276663" cy="2522068"/>
              </a:xfrm>
            </p:grpSpPr>
            <p:sp>
              <p:nvSpPr>
                <p:cNvPr id="27" name="文本框 26">
                  <a:extLst>
                    <a:ext uri="{FF2B5EF4-FFF2-40B4-BE49-F238E27FC236}">
                      <a16:creationId xmlns:a16="http://schemas.microsoft.com/office/drawing/2014/main" id="{0B8B43DD-C8B2-445F-8B68-3BDB29EFFBAB}"/>
                    </a:ext>
                  </a:extLst>
                </p:cNvPr>
                <p:cNvSpPr txBox="1"/>
                <p:nvPr/>
              </p:nvSpPr>
              <p:spPr>
                <a:xfrm>
                  <a:off x="2679391" y="1791820"/>
                  <a:ext cx="2276509" cy="3139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ldo.hc.v1a1.ch14B.g1462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" name="文本框 27">
                  <a:extLst>
                    <a:ext uri="{FF2B5EF4-FFF2-40B4-BE49-F238E27FC236}">
                      <a16:creationId xmlns:a16="http://schemas.microsoft.com/office/drawing/2014/main" id="{0A1307E9-AD15-468E-90AB-B548818D7396}"/>
                    </a:ext>
                  </a:extLst>
                </p:cNvPr>
                <p:cNvSpPr txBox="1"/>
                <p:nvPr/>
              </p:nvSpPr>
              <p:spPr>
                <a:xfrm>
                  <a:off x="2679237" y="1015869"/>
                  <a:ext cx="1453710" cy="3139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si_14B02279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" name="文本框 28">
                  <a:extLst>
                    <a:ext uri="{FF2B5EF4-FFF2-40B4-BE49-F238E27FC236}">
                      <a16:creationId xmlns:a16="http://schemas.microsoft.com/office/drawing/2014/main" id="{3ABE3C2A-D461-4323-A97B-526C79671079}"/>
                    </a:ext>
                  </a:extLst>
                </p:cNvPr>
                <p:cNvSpPr txBox="1"/>
                <p:nvPr/>
              </p:nvSpPr>
              <p:spPr>
                <a:xfrm>
                  <a:off x="2679237" y="1281422"/>
                  <a:ext cx="1383647" cy="3139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sy_14B02089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" name="文本框 29">
                  <a:extLst>
                    <a:ext uri="{FF2B5EF4-FFF2-40B4-BE49-F238E27FC236}">
                      <a16:creationId xmlns:a16="http://schemas.microsoft.com/office/drawing/2014/main" id="{2904CF2A-D7A6-40E3-BA83-750934E84919}"/>
                    </a:ext>
                  </a:extLst>
                </p:cNvPr>
                <p:cNvSpPr txBox="1"/>
                <p:nvPr/>
              </p:nvSpPr>
              <p:spPr>
                <a:xfrm>
                  <a:off x="2686282" y="1521610"/>
                  <a:ext cx="1525195" cy="3139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fusH2_14g02143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" name="文本框 32">
                  <a:extLst>
                    <a:ext uri="{FF2B5EF4-FFF2-40B4-BE49-F238E27FC236}">
                      <a16:creationId xmlns:a16="http://schemas.microsoft.com/office/drawing/2014/main" id="{174521CC-54ED-45F4-87A2-D34F8C7DEB2F}"/>
                    </a:ext>
                  </a:extLst>
                </p:cNvPr>
                <p:cNvSpPr txBox="1"/>
                <p:nvPr/>
              </p:nvSpPr>
              <p:spPr>
                <a:xfrm>
                  <a:off x="2695887" y="756636"/>
                  <a:ext cx="1255233" cy="3139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BA023766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" name="文本框 35">
                  <a:extLst>
                    <a:ext uri="{FF2B5EF4-FFF2-40B4-BE49-F238E27FC236}">
                      <a16:creationId xmlns:a16="http://schemas.microsoft.com/office/drawing/2014/main" id="{2BF02D8A-936C-4A0B-9848-04F34ECEB996}"/>
                    </a:ext>
                  </a:extLst>
                </p:cNvPr>
                <p:cNvSpPr txBox="1"/>
                <p:nvPr/>
              </p:nvSpPr>
              <p:spPr>
                <a:xfrm>
                  <a:off x="2679237" y="2023289"/>
                  <a:ext cx="1568123" cy="3139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uji_hapB_g4028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文本框 36">
                  <a:extLst>
                    <a:ext uri="{FF2B5EF4-FFF2-40B4-BE49-F238E27FC236}">
                      <a16:creationId xmlns:a16="http://schemas.microsoft.com/office/drawing/2014/main" id="{C0051F46-FDC8-4B27-9F26-D413B101852D}"/>
                    </a:ext>
                  </a:extLst>
                </p:cNvPr>
                <p:cNvSpPr txBox="1"/>
                <p:nvPr/>
              </p:nvSpPr>
              <p:spPr>
                <a:xfrm>
                  <a:off x="2679237" y="2288842"/>
                  <a:ext cx="1685298" cy="3224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9_hapB_g15844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文本框 37">
                  <a:extLst>
                    <a:ext uri="{FF2B5EF4-FFF2-40B4-BE49-F238E27FC236}">
                      <a16:creationId xmlns:a16="http://schemas.microsoft.com/office/drawing/2014/main" id="{28938E22-EBE2-469A-A98C-2A9832217B36}"/>
                    </a:ext>
                  </a:extLst>
                </p:cNvPr>
                <p:cNvSpPr txBox="1"/>
                <p:nvPr/>
              </p:nvSpPr>
              <p:spPr>
                <a:xfrm>
                  <a:off x="2679237" y="2519669"/>
                  <a:ext cx="2181137" cy="3139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M106_hapB_g34152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" name="文本框 38">
                  <a:extLst>
                    <a:ext uri="{FF2B5EF4-FFF2-40B4-BE49-F238E27FC236}">
                      <a16:creationId xmlns:a16="http://schemas.microsoft.com/office/drawing/2014/main" id="{8969A02C-3038-4D74-BF57-8C24FC2FA063}"/>
                    </a:ext>
                  </a:extLst>
                </p:cNvPr>
                <p:cNvSpPr txBox="1"/>
                <p:nvPr/>
              </p:nvSpPr>
              <p:spPr>
                <a:xfrm>
                  <a:off x="2693337" y="2772189"/>
                  <a:ext cx="1568123" cy="3139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D14G123450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" name="文本框 39">
                  <a:extLst>
                    <a:ext uri="{FF2B5EF4-FFF2-40B4-BE49-F238E27FC236}">
                      <a16:creationId xmlns:a16="http://schemas.microsoft.com/office/drawing/2014/main" id="{C9DB1485-5C28-4D3B-BA31-BA30E5417E5D}"/>
                    </a:ext>
                  </a:extLst>
                </p:cNvPr>
                <p:cNvSpPr txBox="1"/>
                <p:nvPr/>
              </p:nvSpPr>
              <p:spPr>
                <a:xfrm>
                  <a:off x="2699620" y="564035"/>
                  <a:ext cx="755541" cy="18504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dentity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4" name="图形 3">
                <a:extLst>
                  <a:ext uri="{FF2B5EF4-FFF2-40B4-BE49-F238E27FC236}">
                    <a16:creationId xmlns:a16="http://schemas.microsoft.com/office/drawing/2014/main" id="{36AF811B-6AF6-494E-B909-3CB7FC91C3A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3"/>
                  </a:ext>
                </a:extLst>
              </a:blip>
              <a:srcRect l="24029"/>
              <a:stretch/>
            </p:blipFill>
            <p:spPr>
              <a:xfrm>
                <a:off x="3002452" y="926529"/>
                <a:ext cx="4620126" cy="1799153"/>
              </a:xfrm>
              <a:prstGeom prst="rect">
                <a:avLst/>
              </a:prstGeom>
            </p:spPr>
          </p:pic>
        </p:grpSp>
        <p:grpSp>
          <p:nvGrpSpPr>
            <p:cNvPr id="47" name="组合 46">
              <a:extLst>
                <a:ext uri="{FF2B5EF4-FFF2-40B4-BE49-F238E27FC236}">
                  <a16:creationId xmlns:a16="http://schemas.microsoft.com/office/drawing/2014/main" id="{33EE03A8-18EF-4D88-83ED-82F04D58ED14}"/>
                </a:ext>
              </a:extLst>
            </p:cNvPr>
            <p:cNvGrpSpPr/>
            <p:nvPr/>
          </p:nvGrpSpPr>
          <p:grpSpPr>
            <a:xfrm>
              <a:off x="1650045" y="2964593"/>
              <a:ext cx="5972533" cy="1824129"/>
              <a:chOff x="1650045" y="2964593"/>
              <a:chExt cx="5972533" cy="1824129"/>
            </a:xfrm>
          </p:grpSpPr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EC68FC03-2C9E-4F1B-97DC-67AF1A7D95E6}"/>
                  </a:ext>
                </a:extLst>
              </p:cNvPr>
              <p:cNvSpPr txBox="1"/>
              <p:nvPr/>
            </p:nvSpPr>
            <p:spPr>
              <a:xfrm>
                <a:off x="1650045" y="3809417"/>
                <a:ext cx="151169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do.hc.v1a1.ch14B.g14621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5B35BDA4-17BC-4AF4-8BEB-3611029476E7}"/>
                  </a:ext>
                </a:extLst>
              </p:cNvPr>
              <p:cNvSpPr txBox="1"/>
              <p:nvPr/>
            </p:nvSpPr>
            <p:spPr>
              <a:xfrm>
                <a:off x="1655280" y="3248420"/>
                <a:ext cx="9139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i_14B02128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CF82D7E1-2849-4133-A35F-F73A51B9E8A2}"/>
                  </a:ext>
                </a:extLst>
              </p:cNvPr>
              <p:cNvSpPr txBox="1"/>
              <p:nvPr/>
            </p:nvSpPr>
            <p:spPr>
              <a:xfrm>
                <a:off x="1655280" y="3448825"/>
                <a:ext cx="9139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y_14A02151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45B03B3B-2CFA-4B22-A93D-AAD7EE7C7DB0}"/>
                  </a:ext>
                </a:extLst>
              </p:cNvPr>
              <p:cNvSpPr txBox="1"/>
              <p:nvPr/>
            </p:nvSpPr>
            <p:spPr>
              <a:xfrm>
                <a:off x="1655280" y="3636650"/>
                <a:ext cx="10501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fusH1_14g02229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FDA92DF7-CBDD-45A8-8FF9-F1A13627C812}"/>
                  </a:ext>
                </a:extLst>
              </p:cNvPr>
              <p:cNvSpPr txBox="1"/>
              <p:nvPr/>
            </p:nvSpPr>
            <p:spPr>
              <a:xfrm>
                <a:off x="1655280" y="3098410"/>
                <a:ext cx="82405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BA02376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E8491C80-B793-470A-93CE-2C42A4CA98DD}"/>
                  </a:ext>
                </a:extLst>
              </p:cNvPr>
              <p:cNvSpPr txBox="1"/>
              <p:nvPr/>
            </p:nvSpPr>
            <p:spPr>
              <a:xfrm>
                <a:off x="1655280" y="3969231"/>
                <a:ext cx="109918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uji_hapB_g40284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320DB6E0-C402-4352-BFFE-14C65E045992}"/>
                  </a:ext>
                </a:extLst>
              </p:cNvPr>
              <p:cNvSpPr txBox="1"/>
              <p:nvPr/>
            </p:nvSpPr>
            <p:spPr>
              <a:xfrm>
                <a:off x="1658110" y="4161985"/>
                <a:ext cx="103856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9_hapB_g15843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E6EF8090-12A8-4711-B9D5-5322BF141C7F}"/>
                  </a:ext>
                </a:extLst>
              </p:cNvPr>
              <p:cNvSpPr txBox="1"/>
              <p:nvPr/>
            </p:nvSpPr>
            <p:spPr>
              <a:xfrm>
                <a:off x="1658110" y="4333468"/>
                <a:ext cx="140857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106_hapB_g34153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1E5DB6BE-F857-4C45-B8DC-B54475AC01F0}"/>
                  </a:ext>
                </a:extLst>
              </p:cNvPr>
              <p:cNvSpPr txBox="1"/>
              <p:nvPr/>
            </p:nvSpPr>
            <p:spPr>
              <a:xfrm>
                <a:off x="1658110" y="4520425"/>
                <a:ext cx="109918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D14G123460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222DBDB4-5BDF-4438-90D9-6EC640FB1FD2}"/>
                  </a:ext>
                </a:extLst>
              </p:cNvPr>
              <p:cNvSpPr txBox="1"/>
              <p:nvPr/>
            </p:nvSpPr>
            <p:spPr>
              <a:xfrm>
                <a:off x="1650045" y="2979287"/>
                <a:ext cx="530299" cy="1298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ntity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6" name="图形 5">
                <a:extLst>
                  <a:ext uri="{FF2B5EF4-FFF2-40B4-BE49-F238E27FC236}">
                    <a16:creationId xmlns:a16="http://schemas.microsoft.com/office/drawing/2014/main" id="{C895B080-DF80-437A-8814-E718ECEB265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5"/>
                  </a:ext>
                </a:extLst>
              </a:blip>
              <a:srcRect l="23620"/>
              <a:stretch/>
            </p:blipFill>
            <p:spPr>
              <a:xfrm>
                <a:off x="2974951" y="2964593"/>
                <a:ext cx="4647627" cy="1824129"/>
              </a:xfrm>
              <a:prstGeom prst="rect">
                <a:avLst/>
              </a:prstGeom>
            </p:spPr>
          </p:pic>
        </p:grpSp>
        <p:grpSp>
          <p:nvGrpSpPr>
            <p:cNvPr id="25" name="组合 24">
              <a:extLst>
                <a:ext uri="{FF2B5EF4-FFF2-40B4-BE49-F238E27FC236}">
                  <a16:creationId xmlns:a16="http://schemas.microsoft.com/office/drawing/2014/main" id="{09DE135A-CEE0-456E-AC23-6E336E769BFF}"/>
                </a:ext>
              </a:extLst>
            </p:cNvPr>
            <p:cNvGrpSpPr/>
            <p:nvPr/>
          </p:nvGrpSpPr>
          <p:grpSpPr>
            <a:xfrm>
              <a:off x="7683012" y="976825"/>
              <a:ext cx="1683238" cy="1698559"/>
              <a:chOff x="7683012" y="976825"/>
              <a:chExt cx="1683238" cy="1698559"/>
            </a:xfrm>
          </p:grpSpPr>
          <p:graphicFrame>
            <p:nvGraphicFramePr>
              <p:cNvPr id="49" name="图表 48">
                <a:extLst>
                  <a:ext uri="{FF2B5EF4-FFF2-40B4-BE49-F238E27FC236}">
                    <a16:creationId xmlns:a16="http://schemas.microsoft.com/office/drawing/2014/main" id="{125DDE0B-9C73-4C65-BEF3-982B0B2DF948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7754448" y="976825"/>
              <a:ext cx="1611802" cy="169855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CB6C526D-B2E9-45CD-87F3-1FD99EBBE610}"/>
                  </a:ext>
                </a:extLst>
              </p:cNvPr>
              <p:cNvSpPr txBox="1"/>
              <p:nvPr/>
            </p:nvSpPr>
            <p:spPr>
              <a:xfrm rot="16200000">
                <a:off x="7494031" y="1497204"/>
                <a:ext cx="59340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PKM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6" name="组合 25">
              <a:extLst>
                <a:ext uri="{FF2B5EF4-FFF2-40B4-BE49-F238E27FC236}">
                  <a16:creationId xmlns:a16="http://schemas.microsoft.com/office/drawing/2014/main" id="{8905D823-3B22-4C8E-B057-4EE04B7ED1FC}"/>
                </a:ext>
              </a:extLst>
            </p:cNvPr>
            <p:cNvGrpSpPr/>
            <p:nvPr/>
          </p:nvGrpSpPr>
          <p:grpSpPr>
            <a:xfrm>
              <a:off x="7683012" y="2955496"/>
              <a:ext cx="1727688" cy="1842322"/>
              <a:chOff x="7683012" y="2955496"/>
              <a:chExt cx="1727688" cy="1842322"/>
            </a:xfrm>
          </p:grpSpPr>
          <p:graphicFrame>
            <p:nvGraphicFramePr>
              <p:cNvPr id="58" name="图表 57">
                <a:extLst>
                  <a:ext uri="{FF2B5EF4-FFF2-40B4-BE49-F238E27FC236}">
                    <a16:creationId xmlns:a16="http://schemas.microsoft.com/office/drawing/2014/main" id="{D9632713-258C-4744-BAB7-B1EF49A7C646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7754448" y="2955496"/>
              <a:ext cx="1656252" cy="184232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278A6BBB-A31A-413A-93C3-77E3AEE949E3}"/>
                  </a:ext>
                </a:extLst>
              </p:cNvPr>
              <p:cNvSpPr txBox="1"/>
              <p:nvPr/>
            </p:nvSpPr>
            <p:spPr>
              <a:xfrm rot="16200000">
                <a:off x="7494031" y="3617981"/>
                <a:ext cx="59340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PKM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48BABDC3-2F12-4BBB-AF3A-C1F282544988}"/>
                </a:ext>
              </a:extLst>
            </p:cNvPr>
            <p:cNvSpPr txBox="1"/>
            <p:nvPr/>
          </p:nvSpPr>
          <p:spPr>
            <a:xfrm>
              <a:off x="7964304" y="1032307"/>
              <a:ext cx="89650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14G123450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44DAB253-7FA1-4D54-ACBC-91FBBE542721}"/>
                </a:ext>
              </a:extLst>
            </p:cNvPr>
            <p:cNvSpPr txBox="1"/>
            <p:nvPr/>
          </p:nvSpPr>
          <p:spPr>
            <a:xfrm>
              <a:off x="7981021" y="3017648"/>
              <a:ext cx="89650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14G123460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25075675-D05E-4B45-8A86-E3DF81A104CF}"/>
                </a:ext>
              </a:extLst>
            </p:cNvPr>
            <p:cNvSpPr txBox="1"/>
            <p:nvPr/>
          </p:nvSpPr>
          <p:spPr>
            <a:xfrm>
              <a:off x="1445252" y="838325"/>
              <a:ext cx="1668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82443E96-CBE7-4832-9FAF-6DD785236022}"/>
                </a:ext>
              </a:extLst>
            </p:cNvPr>
            <p:cNvSpPr txBox="1"/>
            <p:nvPr/>
          </p:nvSpPr>
          <p:spPr>
            <a:xfrm>
              <a:off x="7642909" y="863030"/>
              <a:ext cx="1668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5B509A39-D87E-4766-9654-1851CCB0CB33}"/>
                </a:ext>
              </a:extLst>
            </p:cNvPr>
            <p:cNvSpPr txBox="1"/>
            <p:nvPr/>
          </p:nvSpPr>
          <p:spPr>
            <a:xfrm>
              <a:off x="1445252" y="2900349"/>
              <a:ext cx="1668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55595596-FF19-4137-9EF1-A7C1A41E7863}"/>
                </a:ext>
              </a:extLst>
            </p:cNvPr>
            <p:cNvSpPr txBox="1"/>
            <p:nvPr/>
          </p:nvSpPr>
          <p:spPr>
            <a:xfrm>
              <a:off x="7642909" y="2902738"/>
              <a:ext cx="1668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770568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76</Words>
  <Application>Microsoft Office PowerPoint</Application>
  <PresentationFormat>宽屏</PresentationFormat>
  <Paragraphs>2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亚荣</dc:creator>
  <cp:lastModifiedBy>王 亚荣</cp:lastModifiedBy>
  <cp:revision>10</cp:revision>
  <dcterms:created xsi:type="dcterms:W3CDTF">2025-04-18T01:16:52Z</dcterms:created>
  <dcterms:modified xsi:type="dcterms:W3CDTF">2025-04-18T01:27:00Z</dcterms:modified>
</cp:coreProperties>
</file>